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8291175" cy="13717588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17" autoAdjust="0"/>
    <p:restoredTop sz="99306" autoAdjust="0"/>
  </p:normalViewPr>
  <p:slideViewPr>
    <p:cSldViewPr>
      <p:cViewPr>
        <p:scale>
          <a:sx n="90" d="100"/>
          <a:sy n="90" d="100"/>
        </p:scale>
        <p:origin x="966" y="1284"/>
      </p:cViewPr>
      <p:guideLst>
        <p:guide orient="horz" pos="4321"/>
        <p:guide pos="57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1%20&#49892;&#54744;&#49892;\10%20TLR-FN%20&#45436;&#47928;\04%20plos%20one\TLR%20revision%20data\TLR2%20MMP13%20ELIS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1%20&#49892;&#54744;&#49892;\10%20TLR-FN%20&#45436;&#47928;\06%20ART\06%20revision\revision%20data\revision%20figure%20(20150630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30677146983669"/>
          <c:y val="5.1400554097404488E-2"/>
          <c:w val="0.7557836455671596"/>
          <c:h val="0.706468050096535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agellan for F50 Sheet 1'!$A$27</c:f>
              <c:strCache>
                <c:ptCount val="1"/>
                <c:pt idx="0">
                  <c:v>with chondrocyte</c:v>
                </c:pt>
              </c:strCache>
            </c:strRef>
          </c:tx>
          <c:spPr>
            <a:solidFill>
              <a:sysClr val="window" lastClr="FFFFFF"/>
            </a:solidFill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agellan for F50 Sheet 1'!$G$28:$G$32</c:f>
                <c:numCache>
                  <c:formatCode>General</c:formatCode>
                  <c:ptCount val="5"/>
                  <c:pt idx="0">
                    <c:v>73.132511880831558</c:v>
                  </c:pt>
                  <c:pt idx="1">
                    <c:v>157.74316149440838</c:v>
                  </c:pt>
                  <c:pt idx="2">
                    <c:v>109.9864959025288</c:v>
                  </c:pt>
                  <c:pt idx="3">
                    <c:v>49.244641759281627</c:v>
                  </c:pt>
                  <c:pt idx="4">
                    <c:v>99.2057653646365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Magellan for F50 Sheet 1'!$A$28:$A$32</c:f>
              <c:strCache>
                <c:ptCount val="5"/>
                <c:pt idx="0">
                  <c:v>control</c:v>
                </c:pt>
                <c:pt idx="1">
                  <c:v>1/2</c:v>
                </c:pt>
                <c:pt idx="2">
                  <c:v>1/4</c:v>
                </c:pt>
                <c:pt idx="3">
                  <c:v>1/10</c:v>
                </c:pt>
                <c:pt idx="4">
                  <c:v>1/20</c:v>
                </c:pt>
              </c:strCache>
            </c:strRef>
          </c:cat>
          <c:val>
            <c:numRef>
              <c:f>'Magellan for F50 Sheet 1'!$F$28:$F$32</c:f>
              <c:numCache>
                <c:formatCode>General</c:formatCode>
                <c:ptCount val="5"/>
                <c:pt idx="0">
                  <c:v>183.53399999999999</c:v>
                </c:pt>
                <c:pt idx="1">
                  <c:v>2485.3562499999998</c:v>
                </c:pt>
                <c:pt idx="2">
                  <c:v>1048.8497499999999</c:v>
                </c:pt>
                <c:pt idx="3">
                  <c:v>195.29899999999998</c:v>
                </c:pt>
                <c:pt idx="4">
                  <c:v>161.76875000000001</c:v>
                </c:pt>
              </c:numCache>
            </c:numRef>
          </c:val>
        </c:ser>
        <c:ser>
          <c:idx val="1"/>
          <c:order val="1"/>
          <c:tx>
            <c:strRef>
              <c:f>'Magellan for F50 Sheet 1'!$A$33</c:f>
              <c:strCache>
                <c:ptCount val="1"/>
                <c:pt idx="0">
                  <c:v>without chondrocyt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 w="1587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agellan for F50 Sheet 1'!$G$34:$G$38</c:f>
                <c:numCache>
                  <c:formatCode>General</c:formatCode>
                  <c:ptCount val="5"/>
                  <c:pt idx="0">
                    <c:v>77.859652394013779</c:v>
                  </c:pt>
                  <c:pt idx="1">
                    <c:v>44.494933437227985</c:v>
                  </c:pt>
                  <c:pt idx="2">
                    <c:v>99.366157341701779</c:v>
                  </c:pt>
                  <c:pt idx="3">
                    <c:v>19.533679553956688</c:v>
                  </c:pt>
                  <c:pt idx="4">
                    <c:v>113.699255190685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Magellan for F50 Sheet 1'!$F$34:$F$38</c:f>
              <c:numCache>
                <c:formatCode>General</c:formatCode>
                <c:ptCount val="5"/>
                <c:pt idx="0">
                  <c:v>198.24024999999997</c:v>
                </c:pt>
                <c:pt idx="1">
                  <c:v>406.48074999999869</c:v>
                </c:pt>
                <c:pt idx="2">
                  <c:v>301.12517499999899</c:v>
                </c:pt>
                <c:pt idx="3">
                  <c:v>81.766750000000002</c:v>
                </c:pt>
                <c:pt idx="4">
                  <c:v>179.41625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62124032"/>
        <c:axId val="62125952"/>
      </c:barChart>
      <c:catAx>
        <c:axId val="621240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ko-KR" dirty="0" smtClean="0"/>
                  <a:t>Dilution</a:t>
                </a:r>
                <a:r>
                  <a:rPr lang="en-US" altLang="ko-KR" baseline="0" dirty="0" smtClean="0"/>
                  <a:t> </a:t>
                </a:r>
                <a:r>
                  <a:rPr lang="en-US" altLang="ko-KR" baseline="0" dirty="0"/>
                  <a:t>factor</a:t>
                </a:r>
                <a:endParaRPr lang="ko-KR" altLang="en-US" dirty="0"/>
              </a:p>
            </c:rich>
          </c:tx>
          <c:layout>
            <c:manualLayout>
              <c:xMode val="edge"/>
              <c:yMode val="edge"/>
              <c:x val="0.45365414010023675"/>
              <c:y val="0.88808212803186215"/>
            </c:manualLayout>
          </c:layout>
          <c:overlay val="0"/>
        </c:title>
        <c:majorTickMark val="out"/>
        <c:minorTickMark val="none"/>
        <c:tickLblPos val="nextTo"/>
        <c:spPr>
          <a:ln w="15875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62125952"/>
        <c:crosses val="autoZero"/>
        <c:auto val="1"/>
        <c:lblAlgn val="ctr"/>
        <c:lblOffset val="100"/>
        <c:noMultiLvlLbl val="0"/>
      </c:catAx>
      <c:valAx>
        <c:axId val="621259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ko-KR"/>
                  <a:t>MMP-13</a:t>
                </a:r>
                <a:r>
                  <a:rPr lang="en-US" altLang="ko-KR" baseline="0"/>
                  <a:t> (pg/ml)</a:t>
                </a:r>
                <a:endParaRPr lang="ko-KR" altLang="en-US"/>
              </a:p>
            </c:rich>
          </c:tx>
          <c:layout>
            <c:manualLayout>
              <c:xMode val="edge"/>
              <c:yMode val="edge"/>
              <c:x val="1.9847038107578461E-2"/>
              <c:y val="0.1065645617827187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621240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57716336090899956"/>
          <c:y val="6.9060586176727903E-2"/>
          <c:w val="0.4028133825044049"/>
          <c:h val="0.1254799032473882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4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2503221188260578"/>
          <c:y val="0.11033033033033031"/>
          <c:w val="0.73220790582995221"/>
          <c:h val="0.630365167009725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 S2'!$A$22</c:f>
              <c:strCache>
                <c:ptCount val="1"/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FIg S2'!$C$23:$C$28</c:f>
                <c:numCache>
                  <c:formatCode>General</c:formatCode>
                  <c:ptCount val="6"/>
                  <c:pt idx="0">
                    <c:v>11.807120000000499</c:v>
                  </c:pt>
                  <c:pt idx="1">
                    <c:v>51.780301600442463</c:v>
                  </c:pt>
                  <c:pt idx="2">
                    <c:v>58.553897744370055</c:v>
                  </c:pt>
                  <c:pt idx="3">
                    <c:v>11.356027063111252</c:v>
                  </c:pt>
                  <c:pt idx="4">
                    <c:v>48.766652589456832</c:v>
                  </c:pt>
                  <c:pt idx="5">
                    <c:v>29.2757748591977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FIg S2'!$D$23:$D$28</c:f>
              <c:numCache>
                <c:formatCode>General</c:formatCode>
                <c:ptCount val="6"/>
              </c:numCache>
            </c:numRef>
          </c:cat>
          <c:val>
            <c:numRef>
              <c:f>'FIg S2'!$B$23:$B$28</c:f>
              <c:numCache>
                <c:formatCode>General</c:formatCode>
                <c:ptCount val="6"/>
                <c:pt idx="0">
                  <c:v>284.83087999999969</c:v>
                </c:pt>
                <c:pt idx="1">
                  <c:v>928.47029333333319</c:v>
                </c:pt>
                <c:pt idx="2">
                  <c:v>318.7385066666663</c:v>
                </c:pt>
                <c:pt idx="3">
                  <c:v>625.1181333333335</c:v>
                </c:pt>
                <c:pt idx="4">
                  <c:v>460.12119999999948</c:v>
                </c:pt>
                <c:pt idx="5">
                  <c:v>359.306559999999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6500864"/>
        <c:axId val="66506752"/>
      </c:barChart>
      <c:catAx>
        <c:axId val="66500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66506752"/>
        <c:crosses val="autoZero"/>
        <c:auto val="1"/>
        <c:lblAlgn val="ctr"/>
        <c:lblOffset val="100"/>
        <c:noMultiLvlLbl val="0"/>
      </c:catAx>
      <c:valAx>
        <c:axId val="66506752"/>
        <c:scaling>
          <c:orientation val="minMax"/>
          <c:max val="10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ko-KR"/>
                  <a:t>MMP-13</a:t>
                </a:r>
                <a:r>
                  <a:rPr lang="en-US" altLang="ko-KR" baseline="0"/>
                  <a:t> (pg/ml)</a:t>
                </a:r>
                <a:endParaRPr lang="ko-KR" altLang="en-US"/>
              </a:p>
            </c:rich>
          </c:tx>
          <c:layout>
            <c:manualLayout>
              <c:xMode val="edge"/>
              <c:yMode val="edge"/>
              <c:x val="2.3550117459807365E-2"/>
              <c:y val="6.2282282282282303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6500864"/>
        <c:crosses val="autoZero"/>
        <c:crossBetween val="between"/>
        <c:majorUnit val="200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371838" y="4261347"/>
            <a:ext cx="15547499" cy="2940390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2743676" y="7773300"/>
            <a:ext cx="12803823" cy="350560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3261102" y="549343"/>
            <a:ext cx="4115514" cy="1170440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914559" y="549343"/>
            <a:ext cx="12041690" cy="1170440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444878" y="8814824"/>
            <a:ext cx="15547499" cy="272446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444878" y="5814100"/>
            <a:ext cx="15547499" cy="300072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914559" y="3200774"/>
            <a:ext cx="8078602" cy="905297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9298014" y="3200774"/>
            <a:ext cx="8078602" cy="905297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14559" y="3070582"/>
            <a:ext cx="8081779" cy="127967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914559" y="4350254"/>
            <a:ext cx="8081779" cy="79034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9291665" y="3070582"/>
            <a:ext cx="8084953" cy="127967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9291665" y="4350254"/>
            <a:ext cx="8084953" cy="79034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14561" y="546163"/>
            <a:ext cx="6017671" cy="232436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7151342" y="546166"/>
            <a:ext cx="10225275" cy="1170758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914561" y="2870535"/>
            <a:ext cx="6017671" cy="938321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585198" y="9602312"/>
            <a:ext cx="10974705" cy="113360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3585198" y="1225692"/>
            <a:ext cx="10974705" cy="823055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585198" y="10735919"/>
            <a:ext cx="10974705" cy="160991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914559" y="549339"/>
            <a:ext cx="16462058" cy="22862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14559" y="3200774"/>
            <a:ext cx="16462058" cy="90529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914559" y="12714175"/>
            <a:ext cx="4267941" cy="7303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6249486" y="12714175"/>
            <a:ext cx="5792205" cy="7303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13108676" y="12714175"/>
            <a:ext cx="4267941" cy="7303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0" y="0"/>
            <a:ext cx="1903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Additional file 2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216595" y="6156712"/>
            <a:ext cx="10225136" cy="24929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latinLnBrk="0"/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Additional file 2.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The release of MMP-1, -3, and -13 into culture medium in SF-treated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chondrocytes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Chondrocytes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were incubated with sequentially diluted SF for 24 h, washed twice with serum-free DMEM, and incubated in serum-free DMEM for 24 h. Also, control medium was prepared by incubating with diluted SF only without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chondrocytes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, washing with serum-free DMEM, and incubating in serum-free DMEM for 24 h. Then, the medium was collected for analysis of MMP-1, -3, and -13 release into culture medium. 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 The levels of MMP-1 and -3 in culture media were determined using Western blot analysis. C, control; untreated with SF. 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 The expression levels of MMP-13 in culture media were determined using ELISA. Data represent the means ± SD for triplicate experiments from three different donors. * =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&lt; 0.05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vs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 control treated with SF in the absence of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chondrocytes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C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,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 D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 Release of MMP-1, -3, and -13 induced by SF was reduced by neutralization of SF with neutralizing antibody (FN antibody). SF was neutralized with diluted neutralizing antibody (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Fibronectin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antibody (N-20), sc-6953) against FN for 6 h.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Chondrocytes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were exposed for 24 h to the SF, washed twice with serum-free DMEM, and incubated in serum-free DMEM for additional 24 h. Then, the medium was collected for analysis of MMP-1, -3, and -13 release into the culture medium. SF, 1/2 diluted synovial fluid; Dilution factor of neutralization antibody, 1/4, 1/8, and 1/16. 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C.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The levels of MMP-1 and -3 in culture media were determined using western blot analysis. </a:t>
            </a:r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D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 Release of MMP-13 in the culture media was determined using ELISA. Data represent the means ± SD for triplicate experiments from three different donors. # =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&lt; 0.05, ## =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&lt; 0.01, and # =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&lt; 0.001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vs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 untreated control. *** =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&lt; 0.001 </a:t>
            </a:r>
            <a:r>
              <a:rPr lang="en-US" altLang="ko-KR" sz="1200" i="1" dirty="0" smtClean="0">
                <a:latin typeface="Arial" pitchFamily="34" charset="0"/>
                <a:cs typeface="Arial" pitchFamily="34" charset="0"/>
              </a:rPr>
              <a:t>vs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. SF-treated cells. </a:t>
            </a:r>
          </a:p>
        </p:txBody>
      </p:sp>
      <p:grpSp>
        <p:nvGrpSpPr>
          <p:cNvPr id="79" name="그룹 78"/>
          <p:cNvGrpSpPr/>
          <p:nvPr/>
        </p:nvGrpSpPr>
        <p:grpSpPr>
          <a:xfrm>
            <a:off x="216595" y="522090"/>
            <a:ext cx="10297144" cy="5256584"/>
            <a:chOff x="216595" y="522090"/>
            <a:chExt cx="10297144" cy="5256584"/>
          </a:xfrm>
        </p:grpSpPr>
        <p:grpSp>
          <p:nvGrpSpPr>
            <p:cNvPr id="20" name="그룹 19"/>
            <p:cNvGrpSpPr/>
            <p:nvPr/>
          </p:nvGrpSpPr>
          <p:grpSpPr>
            <a:xfrm>
              <a:off x="216595" y="522090"/>
              <a:ext cx="4968552" cy="5256584"/>
              <a:chOff x="216595" y="810122"/>
              <a:chExt cx="4968552" cy="5256584"/>
            </a:xfrm>
          </p:grpSpPr>
          <p:sp>
            <p:nvSpPr>
              <p:cNvPr id="54" name="TextBox 53"/>
              <p:cNvSpPr txBox="1"/>
              <p:nvPr/>
            </p:nvSpPr>
            <p:spPr>
              <a:xfrm>
                <a:off x="648643" y="1843862"/>
                <a:ext cx="76174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dirty="0" smtClean="0">
                    <a:latin typeface="Arial" pitchFamily="34" charset="0"/>
                    <a:cs typeface="Arial" pitchFamily="34" charset="0"/>
                  </a:rPr>
                  <a:t>MMP-1</a:t>
                </a:r>
                <a:endParaRPr lang="ko-KR" altLang="en-US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648643" y="2347918"/>
                <a:ext cx="76174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dirty="0" smtClean="0">
                    <a:latin typeface="Arial" pitchFamily="34" charset="0"/>
                    <a:cs typeface="Arial" pitchFamily="34" charset="0"/>
                  </a:rPr>
                  <a:t>MMP-3</a:t>
                </a:r>
                <a:endParaRPr lang="ko-KR" altLang="en-US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66" name="직선 연결선 65"/>
              <p:cNvCxnSpPr/>
              <p:nvPr/>
            </p:nvCxnSpPr>
            <p:spPr>
              <a:xfrm>
                <a:off x="1584747" y="1386186"/>
                <a:ext cx="1692000" cy="0"/>
              </a:xfrm>
              <a:prstGeom prst="line">
                <a:avLst/>
              </a:prstGeom>
              <a:ln w="349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TextBox 71"/>
              <p:cNvSpPr txBox="1"/>
              <p:nvPr/>
            </p:nvSpPr>
            <p:spPr>
              <a:xfrm>
                <a:off x="1440731" y="1458194"/>
                <a:ext cx="374441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  C    1/2   1/4   1/10  1/20    C   1/2   1/4   1/10  1/20        </a:t>
                </a:r>
                <a:endParaRPr lang="ko-KR" altLang="en-US" sz="1200" b="1" dirty="0" smtClean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216595" y="1458194"/>
                <a:ext cx="12241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Dilution factor</a:t>
                </a:r>
                <a:endParaRPr lang="ko-KR" altLang="en-US" sz="1200" b="1" dirty="0" smtClean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89" name="Picture 2"/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grayscl/>
              </a:blip>
              <a:srcRect t="12311" r="20000" b="23327"/>
              <a:stretch>
                <a:fillRect/>
              </a:stretch>
            </p:blipFill>
            <p:spPr bwMode="auto">
              <a:xfrm>
                <a:off x="1440731" y="1771854"/>
                <a:ext cx="3600000" cy="43204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90" name="Picture 4"/>
              <p:cNvPicPr preferRelativeResize="0">
                <a:picLocks noChangeArrowheads="1"/>
              </p:cNvPicPr>
              <p:nvPr/>
            </p:nvPicPr>
            <p:blipFill>
              <a:blip r:embed="rId3" cstate="print">
                <a:grayscl/>
              </a:blip>
              <a:srcRect l="6186" t="18269" r="22888" b="35490"/>
              <a:stretch>
                <a:fillRect/>
              </a:stretch>
            </p:blipFill>
            <p:spPr bwMode="auto">
              <a:xfrm>
                <a:off x="1440731" y="2275910"/>
                <a:ext cx="3600000" cy="432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cxnSp>
            <p:nvCxnSpPr>
              <p:cNvPr id="91" name="직선 연결선 90"/>
              <p:cNvCxnSpPr/>
              <p:nvPr/>
            </p:nvCxnSpPr>
            <p:spPr>
              <a:xfrm>
                <a:off x="3384947" y="1386186"/>
                <a:ext cx="1692000" cy="0"/>
              </a:xfrm>
              <a:prstGeom prst="line">
                <a:avLst/>
              </a:prstGeom>
              <a:ln w="349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TextBox 91"/>
              <p:cNvSpPr txBox="1"/>
              <p:nvPr/>
            </p:nvSpPr>
            <p:spPr>
              <a:xfrm>
                <a:off x="1656755" y="1098154"/>
                <a:ext cx="165618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with </a:t>
                </a:r>
                <a:r>
                  <a:rPr lang="en-US" altLang="ko-KR" sz="1200" b="1" dirty="0" err="1" smtClean="0">
                    <a:latin typeface="Arial" pitchFamily="34" charset="0"/>
                    <a:cs typeface="Arial" pitchFamily="34" charset="0"/>
                  </a:rPr>
                  <a:t>chondrocytes</a:t>
                </a:r>
                <a:endParaRPr lang="ko-KR" altLang="en-US" sz="1200" b="1" dirty="0" smtClean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3384947" y="1098154"/>
                <a:ext cx="1800200" cy="2880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without </a:t>
                </a:r>
                <a:r>
                  <a:rPr lang="en-US" altLang="ko-KR" sz="1200" b="1" dirty="0" err="1" smtClean="0">
                    <a:latin typeface="Arial" pitchFamily="34" charset="0"/>
                    <a:cs typeface="Arial" pitchFamily="34" charset="0"/>
                  </a:rPr>
                  <a:t>chondrocytes</a:t>
                </a:r>
                <a:endParaRPr lang="ko-KR" altLang="en-US" sz="1200" b="1" dirty="0" smtClean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16595" y="810122"/>
                <a:ext cx="4320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b="1" dirty="0" smtClean="0">
                    <a:latin typeface="Arial" pitchFamily="34" charset="0"/>
                    <a:cs typeface="Arial" pitchFamily="34" charset="0"/>
                  </a:rPr>
                  <a:t>A</a:t>
                </a:r>
                <a:endParaRPr lang="ko-KR" alt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216595" y="3033078"/>
                <a:ext cx="4320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b="1" dirty="0" smtClean="0">
                    <a:latin typeface="Arial" pitchFamily="34" charset="0"/>
                    <a:cs typeface="Arial" pitchFamily="34" charset="0"/>
                  </a:rPr>
                  <a:t>B</a:t>
                </a:r>
                <a:endParaRPr lang="ko-KR" alt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8" name="그룹 27"/>
              <p:cNvGrpSpPr/>
              <p:nvPr/>
            </p:nvGrpSpPr>
            <p:grpSpPr>
              <a:xfrm>
                <a:off x="432619" y="3402410"/>
                <a:ext cx="4608512" cy="2664296"/>
                <a:chOff x="432619" y="3402410"/>
                <a:chExt cx="4608512" cy="2664296"/>
              </a:xfrm>
            </p:grpSpPr>
            <p:graphicFrame>
              <p:nvGraphicFramePr>
                <p:cNvPr id="16" name="차트 15"/>
                <p:cNvGraphicFramePr/>
                <p:nvPr/>
              </p:nvGraphicFramePr>
              <p:xfrm>
                <a:off x="432619" y="3402410"/>
                <a:ext cx="4608512" cy="266429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17" name="TextBox 16"/>
                <p:cNvSpPr txBox="1"/>
                <p:nvPr/>
              </p:nvSpPr>
              <p:spPr>
                <a:xfrm>
                  <a:off x="2152800" y="3492000"/>
                  <a:ext cx="27764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600" b="1" dirty="0" smtClean="0"/>
                    <a:t>*</a:t>
                  </a:r>
                  <a:endParaRPr lang="ko-KR" altLang="en-US" sz="1600" b="1" dirty="0"/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2844000" y="4428000"/>
                  <a:ext cx="27764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600" b="1" dirty="0" smtClean="0"/>
                    <a:t>*</a:t>
                  </a:r>
                  <a:endParaRPr lang="ko-KR" altLang="en-US" sz="1600" b="1" dirty="0"/>
                </a:p>
              </p:txBody>
            </p:sp>
          </p:grpSp>
        </p:grpSp>
        <p:grpSp>
          <p:nvGrpSpPr>
            <p:cNvPr id="78" name="그룹 77"/>
            <p:cNvGrpSpPr/>
            <p:nvPr/>
          </p:nvGrpSpPr>
          <p:grpSpPr>
            <a:xfrm>
              <a:off x="5329163" y="522090"/>
              <a:ext cx="5184576" cy="5256584"/>
              <a:chOff x="5329163" y="522090"/>
              <a:chExt cx="5184576" cy="5256584"/>
            </a:xfrm>
          </p:grpSpPr>
          <p:sp>
            <p:nvSpPr>
              <p:cNvPr id="34" name="TextBox 33"/>
              <p:cNvSpPr txBox="1"/>
              <p:nvPr/>
            </p:nvSpPr>
            <p:spPr>
              <a:xfrm>
                <a:off x="5329163" y="522090"/>
                <a:ext cx="4320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b="1" dirty="0" smtClean="0">
                    <a:latin typeface="Arial" pitchFamily="34" charset="0"/>
                    <a:cs typeface="Arial" pitchFamily="34" charset="0"/>
                  </a:rPr>
                  <a:t>C</a:t>
                </a:r>
                <a:endParaRPr lang="ko-KR" alt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5329163" y="2745046"/>
                <a:ext cx="4320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b="1" dirty="0" smtClean="0">
                    <a:latin typeface="Arial" pitchFamily="34" charset="0"/>
                    <a:cs typeface="Arial" pitchFamily="34" charset="0"/>
                  </a:rPr>
                  <a:t>D</a:t>
                </a:r>
                <a:endParaRPr lang="ko-KR" alt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75" name="그룹 74"/>
              <p:cNvGrpSpPr/>
              <p:nvPr/>
            </p:nvGrpSpPr>
            <p:grpSpPr>
              <a:xfrm>
                <a:off x="5545187" y="2898355"/>
                <a:ext cx="4968552" cy="2880319"/>
                <a:chOff x="5545187" y="2898355"/>
                <a:chExt cx="4968552" cy="2880319"/>
              </a:xfrm>
            </p:grpSpPr>
            <p:graphicFrame>
              <p:nvGraphicFramePr>
                <p:cNvPr id="41" name="차트 40"/>
                <p:cNvGraphicFramePr/>
                <p:nvPr/>
              </p:nvGraphicFramePr>
              <p:xfrm>
                <a:off x="5761211" y="2898355"/>
                <a:ext cx="3771900" cy="261665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grpSp>
              <p:nvGrpSpPr>
                <p:cNvPr id="63" name="그룹 62"/>
                <p:cNvGrpSpPr/>
                <p:nvPr/>
              </p:nvGrpSpPr>
              <p:grpSpPr>
                <a:xfrm>
                  <a:off x="5545187" y="4947207"/>
                  <a:ext cx="4968552" cy="831467"/>
                  <a:chOff x="5545187" y="4698084"/>
                  <a:chExt cx="4968552" cy="831467"/>
                </a:xfrm>
              </p:grpSpPr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9361611" y="4698554"/>
                    <a:ext cx="1152128" cy="83099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SF (1/2)</a:t>
                    </a:r>
                  </a:p>
                  <a:p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 </a:t>
                    </a:r>
                  </a:p>
                  <a:p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Neutralizing </a:t>
                    </a:r>
                  </a:p>
                  <a:p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Antibody</a:t>
                    </a:r>
                    <a:endParaRPr lang="ko-KR" altLang="en-US" sz="12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3" name="TextBox 42"/>
                  <p:cNvSpPr txBox="1"/>
                  <p:nvPr/>
                </p:nvSpPr>
                <p:spPr>
                  <a:xfrm>
                    <a:off x="6697315" y="4698084"/>
                    <a:ext cx="288032" cy="7386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  <a:p>
                    <a:pPr algn="ctr"/>
                    <a:endParaRPr lang="en-US" altLang="ko-KR" sz="1400" b="1" dirty="0" smtClean="0">
                      <a:latin typeface="Arial" pitchFamily="34" charset="0"/>
                      <a:cs typeface="Arial" pitchFamily="34" charset="0"/>
                    </a:endParaRPr>
                  </a:p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  <a:endParaRPr lang="ko-KR" altLang="en-US" sz="14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4" name="TextBox 43"/>
                  <p:cNvSpPr txBox="1"/>
                  <p:nvPr/>
                </p:nvSpPr>
                <p:spPr>
                  <a:xfrm>
                    <a:off x="7057355" y="4698084"/>
                    <a:ext cx="432048" cy="7386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+</a:t>
                    </a:r>
                  </a:p>
                  <a:p>
                    <a:pPr algn="ctr"/>
                    <a:endParaRPr lang="en-US" altLang="ko-KR" sz="1400" b="1" dirty="0" smtClean="0">
                      <a:latin typeface="Arial" pitchFamily="34" charset="0"/>
                      <a:cs typeface="Arial" pitchFamily="34" charset="0"/>
                    </a:endParaRPr>
                  </a:p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  <a:endParaRPr lang="ko-KR" altLang="en-US" sz="14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7561411" y="4698084"/>
                    <a:ext cx="432048" cy="7386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+</a:t>
                    </a:r>
                  </a:p>
                  <a:p>
                    <a:pPr algn="ctr"/>
                    <a:endParaRPr lang="en-US" altLang="ko-KR" sz="1400" b="1" dirty="0" smtClean="0">
                      <a:latin typeface="Arial" pitchFamily="34" charset="0"/>
                      <a:cs typeface="Arial" pitchFamily="34" charset="0"/>
                    </a:endParaRPr>
                  </a:p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1/4</a:t>
                    </a:r>
                    <a:endParaRPr lang="ko-KR" altLang="en-US" sz="14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6" name="TextBox 55"/>
                  <p:cNvSpPr txBox="1"/>
                  <p:nvPr/>
                </p:nvSpPr>
                <p:spPr>
                  <a:xfrm>
                    <a:off x="7993459" y="4698084"/>
                    <a:ext cx="504056" cy="7386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+</a:t>
                    </a:r>
                  </a:p>
                  <a:p>
                    <a:pPr algn="ctr"/>
                    <a:endParaRPr lang="en-US" altLang="ko-KR" sz="1400" b="1" dirty="0" smtClean="0">
                      <a:latin typeface="Arial" pitchFamily="34" charset="0"/>
                      <a:cs typeface="Arial" pitchFamily="34" charset="0"/>
                    </a:endParaRPr>
                  </a:p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1/8</a:t>
                    </a:r>
                  </a:p>
                </p:txBody>
              </p:sp>
              <p:sp>
                <p:nvSpPr>
                  <p:cNvPr id="58" name="TextBox 57"/>
                  <p:cNvSpPr txBox="1"/>
                  <p:nvPr/>
                </p:nvSpPr>
                <p:spPr>
                  <a:xfrm>
                    <a:off x="8425507" y="4698084"/>
                    <a:ext cx="576064" cy="7386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+</a:t>
                    </a:r>
                  </a:p>
                  <a:p>
                    <a:pPr algn="ctr"/>
                    <a:endParaRPr lang="en-US" altLang="ko-KR" sz="1400" b="1" dirty="0" smtClean="0">
                      <a:latin typeface="Arial" pitchFamily="34" charset="0"/>
                      <a:cs typeface="Arial" pitchFamily="34" charset="0"/>
                    </a:endParaRPr>
                  </a:p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1/16</a:t>
                    </a:r>
                    <a:endParaRPr lang="ko-KR" altLang="en-US" sz="14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9" name="TextBox 58"/>
                  <p:cNvSpPr txBox="1"/>
                  <p:nvPr/>
                </p:nvSpPr>
                <p:spPr>
                  <a:xfrm>
                    <a:off x="8929563" y="4698084"/>
                    <a:ext cx="432048" cy="7386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  <a:p>
                    <a:pPr algn="ctr"/>
                    <a:endParaRPr lang="en-US" altLang="ko-KR" sz="1400" b="1" dirty="0" smtClean="0">
                      <a:latin typeface="Arial" pitchFamily="34" charset="0"/>
                      <a:cs typeface="Arial" pitchFamily="34" charset="0"/>
                    </a:endParaRPr>
                  </a:p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1/4</a:t>
                    </a:r>
                    <a:endParaRPr lang="ko-KR" altLang="en-US" sz="14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0" name="TextBox 59"/>
                  <p:cNvSpPr txBox="1"/>
                  <p:nvPr/>
                </p:nvSpPr>
                <p:spPr>
                  <a:xfrm>
                    <a:off x="5545187" y="5148716"/>
                    <a:ext cx="122413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Dilution factor</a:t>
                    </a:r>
                    <a:endParaRPr lang="ko-KR" altLang="en-US" sz="12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64" name="TextBox 63"/>
                <p:cNvSpPr txBox="1"/>
                <p:nvPr/>
              </p:nvSpPr>
              <p:spPr>
                <a:xfrm>
                  <a:off x="7524000" y="3924000"/>
                  <a:ext cx="46358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600" b="1" dirty="0" smtClean="0"/>
                    <a:t>***</a:t>
                  </a:r>
                  <a:endParaRPr lang="ko-KR" altLang="en-US" sz="1600" b="1" dirty="0"/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7992000" y="3492000"/>
                  <a:ext cx="46358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600" b="1" dirty="0" smtClean="0"/>
                    <a:t>***</a:t>
                  </a:r>
                  <a:endParaRPr lang="ko-KR" altLang="en-US" sz="1600" b="1" dirty="0"/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>
                <a:xfrm>
                  <a:off x="8460000" y="3762450"/>
                  <a:ext cx="46358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600" b="1" dirty="0" smtClean="0"/>
                    <a:t>***</a:t>
                  </a:r>
                  <a:endParaRPr lang="ko-KR" altLang="en-US" sz="1600" b="1" dirty="0"/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>
                <a:xfrm>
                  <a:off x="8929563" y="3978474"/>
                  <a:ext cx="46358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600" b="1" dirty="0" smtClean="0"/>
                    <a:t>***</a:t>
                  </a:r>
                  <a:endParaRPr lang="ko-KR" altLang="en-US" sz="1600" b="1" dirty="0"/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9036000" y="3834458"/>
                  <a:ext cx="26962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100" b="1" dirty="0" smtClean="0"/>
                    <a:t>#</a:t>
                  </a:r>
                  <a:endParaRPr lang="ko-KR" altLang="en-US" sz="1100" b="1" dirty="0"/>
                </a:p>
              </p:txBody>
            </p:sp>
            <p:sp>
              <p:nvSpPr>
                <p:cNvPr id="71" name="TextBox 70"/>
                <p:cNvSpPr txBox="1"/>
                <p:nvPr/>
              </p:nvSpPr>
              <p:spPr>
                <a:xfrm>
                  <a:off x="8532000" y="3618434"/>
                  <a:ext cx="35458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100" b="1" dirty="0" smtClean="0"/>
                    <a:t>##</a:t>
                  </a:r>
                  <a:endParaRPr lang="ko-KR" altLang="en-US" sz="1100" b="1" dirty="0"/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7092000" y="2916000"/>
                  <a:ext cx="43954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100" b="1" dirty="0" smtClean="0"/>
                    <a:t>###</a:t>
                  </a:r>
                  <a:endParaRPr lang="ko-KR" altLang="en-US" sz="1100" b="1" dirty="0"/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8010000" y="3284816"/>
                  <a:ext cx="43954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100" b="1" dirty="0" smtClean="0"/>
                    <a:t>###</a:t>
                  </a:r>
                  <a:endParaRPr lang="ko-KR" altLang="en-US" sz="1100" b="1" dirty="0"/>
                </a:p>
              </p:txBody>
            </p:sp>
          </p:grpSp>
          <p:grpSp>
            <p:nvGrpSpPr>
              <p:cNvPr id="77" name="그룹 76"/>
              <p:cNvGrpSpPr/>
              <p:nvPr/>
            </p:nvGrpSpPr>
            <p:grpSpPr>
              <a:xfrm>
                <a:off x="5401171" y="719530"/>
                <a:ext cx="4896544" cy="1699718"/>
                <a:chOff x="5401171" y="719530"/>
                <a:chExt cx="4896544" cy="1699718"/>
              </a:xfrm>
            </p:grpSpPr>
            <p:sp>
              <p:nvSpPr>
                <p:cNvPr id="22" name="TextBox 21"/>
                <p:cNvSpPr txBox="1"/>
                <p:nvPr/>
              </p:nvSpPr>
              <p:spPr>
                <a:xfrm>
                  <a:off x="5761211" y="1555830"/>
                  <a:ext cx="76174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b="1" dirty="0" smtClean="0">
                      <a:latin typeface="Arial" pitchFamily="34" charset="0"/>
                      <a:cs typeface="Arial" pitchFamily="34" charset="0"/>
                    </a:rPr>
                    <a:t>MMP-1</a:t>
                  </a:r>
                  <a:endParaRPr lang="ko-KR" alt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5761211" y="2059886"/>
                  <a:ext cx="76174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400" b="1" dirty="0" smtClean="0">
                      <a:latin typeface="Arial" pitchFamily="34" charset="0"/>
                      <a:cs typeface="Arial" pitchFamily="34" charset="0"/>
                    </a:rPr>
                    <a:t>MMP-3</a:t>
                  </a:r>
                  <a:endParaRPr lang="ko-KR" alt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62" name="그룹 61"/>
                <p:cNvGrpSpPr/>
                <p:nvPr/>
              </p:nvGrpSpPr>
              <p:grpSpPr>
                <a:xfrm>
                  <a:off x="5401171" y="719530"/>
                  <a:ext cx="4896544" cy="831467"/>
                  <a:chOff x="5401171" y="719530"/>
                  <a:chExt cx="4896544" cy="831467"/>
                </a:xfrm>
              </p:grpSpPr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9145587" y="720000"/>
                    <a:ext cx="1152128" cy="83099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SF (1/2)</a:t>
                    </a:r>
                  </a:p>
                  <a:p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 </a:t>
                    </a:r>
                  </a:p>
                  <a:p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Neutralizing </a:t>
                    </a:r>
                  </a:p>
                  <a:p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Antibody</a:t>
                    </a:r>
                    <a:endParaRPr lang="ko-KR" altLang="en-US" sz="12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6697315" y="719530"/>
                    <a:ext cx="288032" cy="7386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  <a:p>
                    <a:pPr algn="ctr"/>
                    <a:endParaRPr lang="en-US" altLang="ko-KR" sz="1400" b="1" dirty="0" smtClean="0">
                      <a:latin typeface="Arial" pitchFamily="34" charset="0"/>
                      <a:cs typeface="Arial" pitchFamily="34" charset="0"/>
                    </a:endParaRPr>
                  </a:p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  <a:endParaRPr lang="ko-KR" altLang="en-US" sz="14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8" name="TextBox 47"/>
                  <p:cNvSpPr txBox="1"/>
                  <p:nvPr/>
                </p:nvSpPr>
                <p:spPr>
                  <a:xfrm>
                    <a:off x="7020000" y="719530"/>
                    <a:ext cx="432048" cy="7386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+</a:t>
                    </a:r>
                  </a:p>
                  <a:p>
                    <a:pPr algn="ctr"/>
                    <a:endParaRPr lang="en-US" altLang="ko-KR" sz="1400" b="1" dirty="0" smtClean="0">
                      <a:latin typeface="Arial" pitchFamily="34" charset="0"/>
                      <a:cs typeface="Arial" pitchFamily="34" charset="0"/>
                    </a:endParaRPr>
                  </a:p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  <a:endParaRPr lang="ko-KR" altLang="en-US" sz="14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7417395" y="719530"/>
                    <a:ext cx="432048" cy="7386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+</a:t>
                    </a:r>
                  </a:p>
                  <a:p>
                    <a:pPr algn="ctr"/>
                    <a:endParaRPr lang="en-US" altLang="ko-KR" sz="1400" b="1" dirty="0" smtClean="0">
                      <a:latin typeface="Arial" pitchFamily="34" charset="0"/>
                      <a:cs typeface="Arial" pitchFamily="34" charset="0"/>
                    </a:endParaRPr>
                  </a:p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1/4</a:t>
                    </a:r>
                    <a:endParaRPr lang="ko-KR" altLang="en-US" sz="14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7777435" y="719530"/>
                    <a:ext cx="504056" cy="7386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+</a:t>
                    </a:r>
                  </a:p>
                  <a:p>
                    <a:pPr algn="ctr"/>
                    <a:endParaRPr lang="en-US" altLang="ko-KR" sz="1400" b="1" dirty="0" smtClean="0">
                      <a:latin typeface="Arial" pitchFamily="34" charset="0"/>
                      <a:cs typeface="Arial" pitchFamily="34" charset="0"/>
                    </a:endParaRPr>
                  </a:p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1/8</a:t>
                    </a:r>
                  </a:p>
                </p:txBody>
              </p:sp>
              <p:sp>
                <p:nvSpPr>
                  <p:cNvPr id="53" name="TextBox 52"/>
                  <p:cNvSpPr txBox="1"/>
                  <p:nvPr/>
                </p:nvSpPr>
                <p:spPr>
                  <a:xfrm>
                    <a:off x="8137475" y="719530"/>
                    <a:ext cx="576064" cy="7386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+</a:t>
                    </a:r>
                  </a:p>
                  <a:p>
                    <a:pPr algn="ctr"/>
                    <a:endParaRPr lang="en-US" altLang="ko-KR" sz="1400" b="1" dirty="0" smtClean="0">
                      <a:latin typeface="Arial" pitchFamily="34" charset="0"/>
                      <a:cs typeface="Arial" pitchFamily="34" charset="0"/>
                    </a:endParaRPr>
                  </a:p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1/16</a:t>
                    </a:r>
                    <a:endParaRPr lang="ko-KR" altLang="en-US" sz="14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7" name="TextBox 56"/>
                  <p:cNvSpPr txBox="1"/>
                  <p:nvPr/>
                </p:nvSpPr>
                <p:spPr>
                  <a:xfrm>
                    <a:off x="8641531" y="719530"/>
                    <a:ext cx="432048" cy="7386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</a:p>
                  <a:p>
                    <a:pPr algn="ctr"/>
                    <a:endParaRPr lang="en-US" altLang="ko-KR" sz="1400" b="1" dirty="0" smtClean="0">
                      <a:latin typeface="Arial" pitchFamily="34" charset="0"/>
                      <a:cs typeface="Arial" pitchFamily="34" charset="0"/>
                    </a:endParaRPr>
                  </a:p>
                  <a:p>
                    <a:pPr algn="ctr"/>
                    <a:r>
                      <a:rPr lang="en-US" altLang="ko-KR" sz="1400" b="1" dirty="0" smtClean="0">
                        <a:latin typeface="Arial" pitchFamily="34" charset="0"/>
                        <a:cs typeface="Arial" pitchFamily="34" charset="0"/>
                      </a:rPr>
                      <a:t>1/4</a:t>
                    </a:r>
                    <a:endParaRPr lang="ko-KR" altLang="en-US" sz="14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1" name="TextBox 60"/>
                  <p:cNvSpPr txBox="1"/>
                  <p:nvPr/>
                </p:nvSpPr>
                <p:spPr>
                  <a:xfrm>
                    <a:off x="5401171" y="1170162"/>
                    <a:ext cx="122413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Dilution factor</a:t>
                    </a:r>
                    <a:endParaRPr lang="ko-KR" altLang="en-US" sz="12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pic>
              <p:nvPicPr>
                <p:cNvPr id="69" name="Picture 6"/>
                <p:cNvPicPr preferRelativeResize="0">
                  <a:picLocks noChangeArrowheads="1"/>
                </p:cNvPicPr>
                <p:nvPr/>
              </p:nvPicPr>
              <p:blipFill>
                <a:blip r:embed="rId6" cstate="print">
                  <a:grayscl/>
                </a:blip>
                <a:srcRect l="10043" t="13753" b="5800"/>
                <a:stretch>
                  <a:fillRect/>
                </a:stretch>
              </p:blipFill>
              <p:spPr bwMode="auto">
                <a:xfrm>
                  <a:off x="6625587" y="1483200"/>
                  <a:ext cx="2520000" cy="432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76" name="Picture 9"/>
                <p:cNvPicPr preferRelativeResize="0">
                  <a:picLocks noChangeArrowheads="1"/>
                </p:cNvPicPr>
                <p:nvPr/>
              </p:nvPicPr>
              <p:blipFill>
                <a:blip r:embed="rId7" cstate="print">
                  <a:grayscl/>
                </a:blip>
                <a:srcRect t="13709" r="5770" b="6093"/>
                <a:stretch>
                  <a:fillRect/>
                </a:stretch>
              </p:blipFill>
              <p:spPr bwMode="auto">
                <a:xfrm>
                  <a:off x="6625307" y="1987200"/>
                  <a:ext cx="2520280" cy="432048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</p:grp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56</TotalTime>
  <Words>462</Words>
  <Application>Microsoft Office PowerPoint</Application>
  <PresentationFormat>Custom</PresentationFormat>
  <Paragraphs>7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er55</dc:creator>
  <cp:lastModifiedBy>Michael Reffold</cp:lastModifiedBy>
  <cp:revision>494</cp:revision>
  <dcterms:created xsi:type="dcterms:W3CDTF">2012-06-29T06:34:17Z</dcterms:created>
  <dcterms:modified xsi:type="dcterms:W3CDTF">2015-09-02T13:21:46Z</dcterms:modified>
</cp:coreProperties>
</file>